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539CD61-C2DE-4F02-B85B-601ADE2C1EC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9" b="3031"/>
          <a:stretch/>
        </p:blipFill>
        <p:spPr>
          <a:xfrm>
            <a:off x="2746191" y="1063486"/>
            <a:ext cx="6699618" cy="5715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E5A137B3-5658-41AA-949F-14D92D7661B9}"/>
              </a:ext>
            </a:extLst>
          </p:cNvPr>
          <p:cNvSpPr/>
          <p:nvPr/>
        </p:nvSpPr>
        <p:spPr>
          <a:xfrm>
            <a:off x="276445" y="223859"/>
            <a:ext cx="1146166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altLang="zh-CN" sz="1400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Subgroup meta-analysis regarding cerebrospinal fluid Ng levels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in patients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400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in age matched and age mismatched groups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891 individuals from 19 studies. The squares indicate individual study SMD and their corresponding 95% CIs and the sizes of the squares are proportional to study weight. AD, Alzheimer’s disease. HC, healthy controls. CSF, cerebrospinal fluid. SMD, standard mean difference. CI, confidence interval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b="1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1781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6</TotalTime>
  <Words>85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01:21:34Z</dcterms:modified>
</cp:coreProperties>
</file>